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4" d="100"/>
          <a:sy n="64" d="100"/>
        </p:scale>
        <p:origin x="-2754" y="-1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Graphique%20dans%20Microsoft%20PowerPoint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19177319397508"/>
          <c:y val="4.1095929679788479E-2"/>
          <c:w val="0.82414320398886753"/>
          <c:h val="0.72973479432192634"/>
        </c:manualLayout>
      </c:layout>
      <c:barChart>
        <c:barDir val="col"/>
        <c:grouping val="clustered"/>
        <c:varyColors val="0"/>
        <c:ser>
          <c:idx val="0"/>
          <c:order val="0"/>
          <c:tx>
            <c:v>R3:1</c:v>
          </c:tx>
          <c:spPr>
            <a:solidFill>
              <a:schemeClr val="accent1">
                <a:lumMod val="75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G:\PME\Publi rafts cricri\Projets RAFTS\[SphingolipidsJLC07-01-11.xls]Mol.%'!$C$13:$C$20</c:f>
              <c:strCache>
                <c:ptCount val="8"/>
                <c:pt idx="0">
                  <c:v>t18:1(8Z)</c:v>
                </c:pt>
                <c:pt idx="1">
                  <c:v>t18:1(8E)</c:v>
                </c:pt>
                <c:pt idx="2">
                  <c:v>t18:0</c:v>
                </c:pt>
                <c:pt idx="3">
                  <c:v>d18:1(8Z)</c:v>
                </c:pt>
                <c:pt idx="4">
                  <c:v>d18:1(8E)</c:v>
                </c:pt>
                <c:pt idx="5">
                  <c:v>d18:0</c:v>
                </c:pt>
                <c:pt idx="6">
                  <c:v>d18:2(4E,8E,Z)</c:v>
                </c:pt>
                <c:pt idx="7">
                  <c:v>d18:1(4E)</c:v>
                </c:pt>
              </c:strCache>
            </c:strRef>
          </c:cat>
          <c:val>
            <c:numRef>
              <c:f>'G:\PME\Publi rafts cricri\Projets RAFTS\[SphingolipidsJLC07-01-11.xls]Mol.%'!$D$13:$D$20</c:f>
              <c:numCache>
                <c:formatCode>General</c:formatCode>
                <c:ptCount val="8"/>
                <c:pt idx="0">
                  <c:v>7.7800923076427058</c:v>
                </c:pt>
                <c:pt idx="1">
                  <c:v>65.780360568602632</c:v>
                </c:pt>
                <c:pt idx="2">
                  <c:v>17.89360673488255</c:v>
                </c:pt>
                <c:pt idx="3">
                  <c:v>2.3289436504388732</c:v>
                </c:pt>
                <c:pt idx="4">
                  <c:v>3.4565062672999276</c:v>
                </c:pt>
                <c:pt idx="5">
                  <c:v>0.91316737570564144</c:v>
                </c:pt>
                <c:pt idx="6">
                  <c:v>1.59648780823225</c:v>
                </c:pt>
                <c:pt idx="7">
                  <c:v>0.25083528719540987</c:v>
                </c:pt>
              </c:numCache>
            </c:numRef>
          </c:val>
        </c:ser>
        <c:ser>
          <c:idx val="1"/>
          <c:order val="1"/>
          <c:tx>
            <c:v>R3:2</c:v>
          </c:tx>
          <c:spPr>
            <a:pattFill prst="wdDnDiag">
              <a:fgClr>
                <a:schemeClr val="accent1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G:\PME\Publi rafts cricri\Projets RAFTS\[SphingolipidsJLC07-01-11.xls]Mol.%'!$C$13:$C$20</c:f>
              <c:strCache>
                <c:ptCount val="8"/>
                <c:pt idx="0">
                  <c:v>t18:1(8Z)</c:v>
                </c:pt>
                <c:pt idx="1">
                  <c:v>t18:1(8E)</c:v>
                </c:pt>
                <c:pt idx="2">
                  <c:v>t18:0</c:v>
                </c:pt>
                <c:pt idx="3">
                  <c:v>d18:1(8Z)</c:v>
                </c:pt>
                <c:pt idx="4">
                  <c:v>d18:1(8E)</c:v>
                </c:pt>
                <c:pt idx="5">
                  <c:v>d18:0</c:v>
                </c:pt>
                <c:pt idx="6">
                  <c:v>d18:2(4E,8E,Z)</c:v>
                </c:pt>
                <c:pt idx="7">
                  <c:v>d18:1(4E)</c:v>
                </c:pt>
              </c:strCache>
            </c:strRef>
          </c:cat>
          <c:val>
            <c:numRef>
              <c:f>'G:\PME\Publi rafts cricri\Projets RAFTS\[SphingolipidsJLC07-01-11.xls]Mol.%'!$E$13:$E$20</c:f>
              <c:numCache>
                <c:formatCode>General</c:formatCode>
                <c:ptCount val="8"/>
                <c:pt idx="0">
                  <c:v>7.1931967845123994</c:v>
                </c:pt>
                <c:pt idx="1">
                  <c:v>70.629933065518273</c:v>
                </c:pt>
                <c:pt idx="2">
                  <c:v>17.813325285259197</c:v>
                </c:pt>
                <c:pt idx="3">
                  <c:v>0.81423998686606058</c:v>
                </c:pt>
                <c:pt idx="4">
                  <c:v>1.8942230483862335</c:v>
                </c:pt>
                <c:pt idx="5">
                  <c:v>0.45550367532253666</c:v>
                </c:pt>
                <c:pt idx="6">
                  <c:v>0.77998745824670324</c:v>
                </c:pt>
                <c:pt idx="7">
                  <c:v>0.41959069588859615</c:v>
                </c:pt>
              </c:numCache>
            </c:numRef>
          </c:val>
        </c:ser>
        <c:ser>
          <c:idx val="2"/>
          <c:order val="2"/>
          <c:tx>
            <c:v>R6:1</c:v>
          </c:tx>
          <c:spPr>
            <a:solidFill>
              <a:schemeClr val="accent1">
                <a:lumMod val="20000"/>
                <a:lumOff val="80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1"/>
            <c:invertIfNegative val="0"/>
            <c:bubble3D val="0"/>
            <c:spPr>
              <a:pattFill prst="wdDnDiag">
                <a:fgClr>
                  <a:schemeClr val="accent1">
                    <a:lumMod val="20000"/>
                    <a:lumOff val="80000"/>
                  </a:schemeClr>
                </a:fgClr>
                <a:bgClr>
                  <a:schemeClr val="bg1"/>
                </a:bgClr>
              </a:pattFill>
              <a:ln w="12700">
                <a:solidFill>
                  <a:srgbClr val="000000"/>
                </a:solidFill>
                <a:prstDash val="solid"/>
              </a:ln>
            </c:spPr>
          </c:dPt>
          <c:cat>
            <c:strRef>
              <c:f>'G:\PME\Publi rafts cricri\Projets RAFTS\[SphingolipidsJLC07-01-11.xls]Mol.%'!$C$13:$C$20</c:f>
              <c:strCache>
                <c:ptCount val="8"/>
                <c:pt idx="0">
                  <c:v>t18:1(8Z)</c:v>
                </c:pt>
                <c:pt idx="1">
                  <c:v>t18:1(8E)</c:v>
                </c:pt>
                <c:pt idx="2">
                  <c:v>t18:0</c:v>
                </c:pt>
                <c:pt idx="3">
                  <c:v>d18:1(8Z)</c:v>
                </c:pt>
                <c:pt idx="4">
                  <c:v>d18:1(8E)</c:v>
                </c:pt>
                <c:pt idx="5">
                  <c:v>d18:0</c:v>
                </c:pt>
                <c:pt idx="6">
                  <c:v>d18:2(4E,8E,Z)</c:v>
                </c:pt>
                <c:pt idx="7">
                  <c:v>d18:1(4E)</c:v>
                </c:pt>
              </c:strCache>
            </c:strRef>
          </c:cat>
          <c:val>
            <c:numRef>
              <c:f>'G:\PME\Publi rafts cricri\Projets RAFTS\[SphingolipidsJLC07-01-11.xls]Mol.%'!$F$13:$F$20</c:f>
              <c:numCache>
                <c:formatCode>General</c:formatCode>
                <c:ptCount val="8"/>
                <c:pt idx="0">
                  <c:v>6.1934362323569889</c:v>
                </c:pt>
                <c:pt idx="1">
                  <c:v>65.012996708761676</c:v>
                </c:pt>
                <c:pt idx="2">
                  <c:v>22.523911865835419</c:v>
                </c:pt>
                <c:pt idx="3">
                  <c:v>1.8564632099452474</c:v>
                </c:pt>
                <c:pt idx="4">
                  <c:v>2.8222960764672598</c:v>
                </c:pt>
                <c:pt idx="5">
                  <c:v>0.53322431004419912</c:v>
                </c:pt>
                <c:pt idx="6">
                  <c:v>0.81353012786337675</c:v>
                </c:pt>
                <c:pt idx="7">
                  <c:v>0.24414146872584019</c:v>
                </c:pt>
              </c:numCache>
            </c:numRef>
          </c:val>
        </c:ser>
        <c:ser>
          <c:idx val="4"/>
          <c:order val="3"/>
          <c:tx>
            <c:v>G3:1</c:v>
          </c:tx>
          <c:spPr>
            <a:pattFill prst="wdDnDiag">
              <a:fgClr>
                <a:schemeClr val="accent2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G:\PME\Publi rafts cricri\Projets RAFTS\[SphingolipidsJLC07-01-11.xls]Mol.%'!$C$13:$C$20</c:f>
              <c:strCache>
                <c:ptCount val="8"/>
                <c:pt idx="0">
                  <c:v>t18:1(8Z)</c:v>
                </c:pt>
                <c:pt idx="1">
                  <c:v>t18:1(8E)</c:v>
                </c:pt>
                <c:pt idx="2">
                  <c:v>t18:0</c:v>
                </c:pt>
                <c:pt idx="3">
                  <c:v>d18:1(8Z)</c:v>
                </c:pt>
                <c:pt idx="4">
                  <c:v>d18:1(8E)</c:v>
                </c:pt>
                <c:pt idx="5">
                  <c:v>d18:0</c:v>
                </c:pt>
                <c:pt idx="6">
                  <c:v>d18:2(4E,8E,Z)</c:v>
                </c:pt>
                <c:pt idx="7">
                  <c:v>d18:1(4E)</c:v>
                </c:pt>
              </c:strCache>
            </c:strRef>
          </c:cat>
          <c:val>
            <c:numRef>
              <c:f>'G:\PME\Publi rafts cricri\Projets RAFTS\[SphingolipidsJLC07-01-11.xls]Mol.%'!$H$13:$H$20</c:f>
              <c:numCache>
                <c:formatCode>General</c:formatCode>
                <c:ptCount val="8"/>
                <c:pt idx="0">
                  <c:v>8.1378681060902789</c:v>
                </c:pt>
                <c:pt idx="1">
                  <c:v>66.741687477232531</c:v>
                </c:pt>
                <c:pt idx="2">
                  <c:v>18.930871356992466</c:v>
                </c:pt>
                <c:pt idx="3">
                  <c:v>1.2192332597410214</c:v>
                </c:pt>
                <c:pt idx="4">
                  <c:v>2.7665834381385994</c:v>
                </c:pt>
                <c:pt idx="5">
                  <c:v>0.65960535659988973</c:v>
                </c:pt>
                <c:pt idx="6">
                  <c:v>1.4752808703367788</c:v>
                </c:pt>
                <c:pt idx="7">
                  <c:v>6.8870134868416477E-2</c:v>
                </c:pt>
              </c:numCache>
            </c:numRef>
          </c:val>
        </c:ser>
        <c:ser>
          <c:idx val="5"/>
          <c:order val="4"/>
          <c:tx>
            <c:v>G3:2</c:v>
          </c:tx>
          <c:spPr>
            <a:solidFill>
              <a:schemeClr val="accent2">
                <a:lumMod val="60000"/>
                <a:lumOff val="40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G:\PME\Publi rafts cricri\Projets RAFTS\[SphingolipidsJLC07-01-11.xls]Mol.%'!$C$13:$C$20</c:f>
              <c:strCache>
                <c:ptCount val="8"/>
                <c:pt idx="0">
                  <c:v>t18:1(8Z)</c:v>
                </c:pt>
                <c:pt idx="1">
                  <c:v>t18:1(8E)</c:v>
                </c:pt>
                <c:pt idx="2">
                  <c:v>t18:0</c:v>
                </c:pt>
                <c:pt idx="3">
                  <c:v>d18:1(8Z)</c:v>
                </c:pt>
                <c:pt idx="4">
                  <c:v>d18:1(8E)</c:v>
                </c:pt>
                <c:pt idx="5">
                  <c:v>d18:0</c:v>
                </c:pt>
                <c:pt idx="6">
                  <c:v>d18:2(4E,8E,Z)</c:v>
                </c:pt>
                <c:pt idx="7">
                  <c:v>d18:1(4E)</c:v>
                </c:pt>
              </c:strCache>
            </c:strRef>
          </c:cat>
          <c:val>
            <c:numRef>
              <c:f>'G:\PME\Publi rafts cricri\Projets RAFTS\[SphingolipidsJLC07-01-11.xls]Mol.%'!$I$13:$I$20</c:f>
              <c:numCache>
                <c:formatCode>General</c:formatCode>
                <c:ptCount val="8"/>
                <c:pt idx="0">
                  <c:v>8.4142653057767163</c:v>
                </c:pt>
                <c:pt idx="1">
                  <c:v>71.066727032696704</c:v>
                </c:pt>
                <c:pt idx="2">
                  <c:v>15.789993213753034</c:v>
                </c:pt>
                <c:pt idx="3">
                  <c:v>0.40553269942224862</c:v>
                </c:pt>
                <c:pt idx="4">
                  <c:v>1.897075290329304</c:v>
                </c:pt>
                <c:pt idx="5">
                  <c:v>0.52833847143858315</c:v>
                </c:pt>
                <c:pt idx="6">
                  <c:v>1.8394293090244791</c:v>
                </c:pt>
                <c:pt idx="7">
                  <c:v>5.8638677558916281E-2</c:v>
                </c:pt>
              </c:numCache>
            </c:numRef>
          </c:val>
        </c:ser>
        <c:ser>
          <c:idx val="7"/>
          <c:order val="5"/>
          <c:tx>
            <c:v>G6:2</c:v>
          </c:tx>
          <c:spPr>
            <a:solidFill>
              <a:schemeClr val="accent2">
                <a:lumMod val="40000"/>
                <a:lumOff val="60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1"/>
            <c:invertIfNegative val="0"/>
            <c:bubble3D val="0"/>
            <c:spPr>
              <a:pattFill prst="wdDnDiag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 w="12700">
                <a:solidFill>
                  <a:srgbClr val="000000"/>
                </a:solidFill>
                <a:prstDash val="solid"/>
              </a:ln>
            </c:spPr>
          </c:dPt>
          <c:cat>
            <c:strRef>
              <c:f>'G:\PME\Publi rafts cricri\Projets RAFTS\[SphingolipidsJLC07-01-11.xls]Mol.%'!$C$13:$C$20</c:f>
              <c:strCache>
                <c:ptCount val="8"/>
                <c:pt idx="0">
                  <c:v>t18:1(8Z)</c:v>
                </c:pt>
                <c:pt idx="1">
                  <c:v>t18:1(8E)</c:v>
                </c:pt>
                <c:pt idx="2">
                  <c:v>t18:0</c:v>
                </c:pt>
                <c:pt idx="3">
                  <c:v>d18:1(8Z)</c:v>
                </c:pt>
                <c:pt idx="4">
                  <c:v>d18:1(8E)</c:v>
                </c:pt>
                <c:pt idx="5">
                  <c:v>d18:0</c:v>
                </c:pt>
                <c:pt idx="6">
                  <c:v>d18:2(4E,8E,Z)</c:v>
                </c:pt>
                <c:pt idx="7">
                  <c:v>d18:1(4E)</c:v>
                </c:pt>
              </c:strCache>
            </c:strRef>
          </c:cat>
          <c:val>
            <c:numRef>
              <c:f>'G:\PME\Publi rafts cricri\Projets RAFTS\[SphingolipidsJLC07-01-11.xls]Mol.%'!$K$13:$K$20</c:f>
              <c:numCache>
                <c:formatCode>General</c:formatCode>
                <c:ptCount val="8"/>
                <c:pt idx="0">
                  <c:v>7.1252157341508129</c:v>
                </c:pt>
                <c:pt idx="1">
                  <c:v>64.262481131521426</c:v>
                </c:pt>
                <c:pt idx="2">
                  <c:v>23.10039709611647</c:v>
                </c:pt>
                <c:pt idx="3">
                  <c:v>0.82042295110043817</c:v>
                </c:pt>
                <c:pt idx="4">
                  <c:v>2.1781329944986769</c:v>
                </c:pt>
                <c:pt idx="5">
                  <c:v>0.76858414527747754</c:v>
                </c:pt>
                <c:pt idx="6">
                  <c:v>1.6605605256604774</c:v>
                </c:pt>
                <c:pt idx="7">
                  <c:v>8.420542167421354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216640"/>
        <c:axId val="103252736"/>
      </c:barChart>
      <c:catAx>
        <c:axId val="103216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162000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10325273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32527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fr-FR" b="0"/>
                  <a:t>Mol. %</a:t>
                </a:r>
              </a:p>
            </c:rich>
          </c:tx>
          <c:layout>
            <c:manualLayout>
              <c:xMode val="edge"/>
              <c:yMode val="edge"/>
              <c:x val="3.3420650017322286E-2"/>
              <c:y val="0.3818676239414632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103216640"/>
        <c:crosses val="autoZero"/>
        <c:crossBetween val="between"/>
      </c:valAx>
      <c:spPr>
        <a:solidFill>
          <a:srgbClr val="FFFFFF"/>
        </a:solidFill>
        <a:ln w="12700">
          <a:noFill/>
          <a:prstDash val="solid"/>
        </a:ln>
      </c:spPr>
    </c:plotArea>
    <c:legend>
      <c:legendPos val="r"/>
      <c:layout>
        <c:manualLayout>
          <c:xMode val="edge"/>
          <c:yMode val="edge"/>
          <c:x val="0.85252498367281559"/>
          <c:y val="8.8021120647590295E-2"/>
          <c:w val="0.10990129754907396"/>
          <c:h val="0.64133976403634485"/>
        </c:manualLayout>
      </c:layout>
      <c:overlay val="0"/>
      <c:spPr>
        <a:solidFill>
          <a:srgbClr val="FFFFFF"/>
        </a:solidFill>
        <a:ln w="25400">
          <a:noFill/>
        </a:ln>
      </c:spPr>
      <c:txPr>
        <a:bodyPr/>
        <a:lstStyle/>
        <a:p>
          <a:pPr>
            <a:defRPr sz="1200" b="0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fr-FR"/>
        </a:p>
      </c:tx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52308617224869"/>
          <c:y val="3.2894996655456969E-2"/>
          <c:w val="0.817050645479799"/>
          <c:h val="0.809369618691480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on recommence,,,'!$Q$6</c:f>
              <c:strCache>
                <c:ptCount val="1"/>
                <c:pt idx="0">
                  <c:v>Q sterols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1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2"/>
            <c:invertIfNegative val="0"/>
            <c:bubble3D val="0"/>
            <c:spPr>
              <a:pattFill prst="ltDnDiag">
                <a:fgClr>
                  <a:schemeClr val="accent1">
                    <a:lumMod val="60000"/>
                    <a:lumOff val="40000"/>
                  </a:schemeClr>
                </a:fgClr>
                <a:bgClr>
                  <a:schemeClr val="bg1"/>
                </a:bgClr>
              </a:patt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3"/>
            <c:invertIfNegative val="0"/>
            <c:bubble3D val="0"/>
            <c:spPr>
              <a:pattFill prst="ltDnDiag">
                <a:fgClr>
                  <a:schemeClr val="accent1">
                    <a:lumMod val="20000"/>
                    <a:lumOff val="80000"/>
                  </a:schemeClr>
                </a:fgClr>
                <a:bgClr>
                  <a:schemeClr val="bg1"/>
                </a:bgClr>
              </a:patt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4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5"/>
            <c:invertIfNegative val="0"/>
            <c:bubble3D val="0"/>
            <c:spPr>
              <a:pattFill prst="ltDnDiag">
                <a:fgClr>
                  <a:schemeClr val="accent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6"/>
            <c:invertIfNegative val="0"/>
            <c:bubble3D val="0"/>
            <c:spPr>
              <a:pattFill prst="ltDnDiag">
                <a:fgClr>
                  <a:schemeClr val="accent2">
                    <a:lumMod val="20000"/>
                    <a:lumOff val="80000"/>
                  </a:schemeClr>
                </a:fgClr>
                <a:bgClr>
                  <a:schemeClr val="bg1"/>
                </a:bgClr>
              </a:pattFill>
              <a:ln w="12700">
                <a:solidFill>
                  <a:srgbClr val="000000"/>
                </a:solidFill>
                <a:prstDash val="solid"/>
              </a:ln>
            </c:spPr>
          </c:dPt>
          <c:errBars>
            <c:errBarType val="both"/>
            <c:errValType val="cust"/>
            <c:noEndCap val="0"/>
            <c:plus>
              <c:numRef>
                <c:f>'on recommence,,,'!$R$7:$X$7</c:f>
                <c:numCache>
                  <c:formatCode>General</c:formatCode>
                  <c:ptCount val="7"/>
                  <c:pt idx="0">
                    <c:v>0.88067872113728707</c:v>
                  </c:pt>
                  <c:pt idx="1">
                    <c:v>1.1101046232980913</c:v>
                  </c:pt>
                  <c:pt idx="2">
                    <c:v>1.090960879236031</c:v>
                  </c:pt>
                  <c:pt idx="3">
                    <c:v>6.0189104429396477E-2</c:v>
                  </c:pt>
                  <c:pt idx="4">
                    <c:v>1.1080319630921378</c:v>
                  </c:pt>
                  <c:pt idx="5">
                    <c:v>1.8934672493524323</c:v>
                  </c:pt>
                  <c:pt idx="6">
                    <c:v>0.21584973417632153</c:v>
                  </c:pt>
                </c:numCache>
              </c:numRef>
            </c:plus>
            <c:minus>
              <c:numRef>
                <c:f>'on recommence,,,'!$R$7:$Y$7</c:f>
                <c:numCache>
                  <c:formatCode>General</c:formatCode>
                  <c:ptCount val="8"/>
                  <c:pt idx="0">
                    <c:v>0.88067872113728707</c:v>
                  </c:pt>
                  <c:pt idx="1">
                    <c:v>1.1101046232980913</c:v>
                  </c:pt>
                  <c:pt idx="2">
                    <c:v>1.090960879236031</c:v>
                  </c:pt>
                  <c:pt idx="3">
                    <c:v>6.0189104429396477E-2</c:v>
                  </c:pt>
                  <c:pt idx="4">
                    <c:v>1.1080319630921378</c:v>
                  </c:pt>
                  <c:pt idx="5">
                    <c:v>1.8934672493524323</c:v>
                  </c:pt>
                  <c:pt idx="6">
                    <c:v>0.21584973417632153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on recommence,,,'!$R$5:$X$5</c:f>
              <c:strCache>
                <c:ptCount val="7"/>
                <c:pt idx="0">
                  <c:v>Mic</c:v>
                </c:pt>
                <c:pt idx="1">
                  <c:v>R3:1</c:v>
                </c:pt>
                <c:pt idx="2">
                  <c:v>R3:2</c:v>
                </c:pt>
                <c:pt idx="3">
                  <c:v>R6:1</c:v>
                </c:pt>
                <c:pt idx="4">
                  <c:v>G3:2</c:v>
                </c:pt>
                <c:pt idx="5">
                  <c:v>G3:1</c:v>
                </c:pt>
                <c:pt idx="6">
                  <c:v>G6:2</c:v>
                </c:pt>
              </c:strCache>
            </c:strRef>
          </c:cat>
          <c:val>
            <c:numRef>
              <c:f>'on recommence,,,'!$R$6:$X$6</c:f>
              <c:numCache>
                <c:formatCode>General</c:formatCode>
                <c:ptCount val="7"/>
                <c:pt idx="0">
                  <c:v>2.6646934158976694</c:v>
                </c:pt>
                <c:pt idx="1">
                  <c:v>7.5914794632246059</c:v>
                </c:pt>
                <c:pt idx="2">
                  <c:v>6.4843130103568072</c:v>
                </c:pt>
                <c:pt idx="3">
                  <c:v>6.7723238508576173</c:v>
                </c:pt>
                <c:pt idx="4">
                  <c:v>10.722883420679898</c:v>
                </c:pt>
                <c:pt idx="5">
                  <c:v>10.695007530230837</c:v>
                </c:pt>
                <c:pt idx="6">
                  <c:v>10.0298018999637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axId val="104605952"/>
        <c:axId val="104632704"/>
      </c:barChart>
      <c:catAx>
        <c:axId val="104605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104632704"/>
        <c:crosses val="autoZero"/>
        <c:auto val="1"/>
        <c:lblAlgn val="ctr"/>
        <c:lblOffset val="0"/>
        <c:tickLblSkip val="1"/>
        <c:tickMarkSkip val="1"/>
        <c:noMultiLvlLbl val="0"/>
      </c:catAx>
      <c:valAx>
        <c:axId val="10463270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fr-FR" sz="1200" b="0" dirty="0"/>
                  <a:t>µg </a:t>
                </a:r>
                <a:r>
                  <a:rPr lang="fr-FR" sz="1200" b="0" dirty="0" err="1"/>
                  <a:t>sterol</a:t>
                </a:r>
                <a:r>
                  <a:rPr lang="fr-FR" sz="1200" b="0" dirty="0"/>
                  <a:t>/100µg </a:t>
                </a:r>
                <a:r>
                  <a:rPr lang="fr-FR" sz="1200" b="0" dirty="0" err="1" smtClean="0"/>
                  <a:t>proteins</a:t>
                </a:r>
                <a:endParaRPr lang="fr-FR" sz="1200" b="0" dirty="0"/>
              </a:p>
            </c:rich>
          </c:tx>
          <c:layout>
            <c:manualLayout>
              <c:xMode val="edge"/>
              <c:yMode val="edge"/>
              <c:x val="2.8429227161685239E-4"/>
              <c:y val="0.1936122400672278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10460595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27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5592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5988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8737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0399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4339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8034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706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4100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1590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4225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439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C0355-6773-49C5-AA5D-CF74234C123B}" type="datetimeFigureOut">
              <a:rPr lang="fr-FR" smtClean="0"/>
              <a:t>26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1EAB3-3454-42DC-9962-F9350CB298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8859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122592" y="35496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(A)</a:t>
            </a:r>
            <a:endParaRPr lang="fr-FR" b="1" dirty="0"/>
          </a:p>
        </p:txBody>
      </p:sp>
      <p:sp>
        <p:nvSpPr>
          <p:cNvPr id="5" name="ZoneTexte 4"/>
          <p:cNvSpPr txBox="1"/>
          <p:nvPr/>
        </p:nvSpPr>
        <p:spPr>
          <a:xfrm>
            <a:off x="122593" y="2987824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(B)</a:t>
            </a:r>
            <a:endParaRPr lang="fr-FR" b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0257156"/>
              </p:ext>
            </p:extLst>
          </p:nvPr>
        </p:nvGraphicFramePr>
        <p:xfrm>
          <a:off x="351983" y="3357156"/>
          <a:ext cx="5813322" cy="43919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3971450"/>
              </p:ext>
            </p:extLst>
          </p:nvPr>
        </p:nvGraphicFramePr>
        <p:xfrm>
          <a:off x="590990" y="35496"/>
          <a:ext cx="5646322" cy="35782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0" y="7570202"/>
            <a:ext cx="685799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/>
              <a:t>Additional</a:t>
            </a:r>
            <a:r>
              <a:rPr lang="fr-FR" sz="1200" b="1" dirty="0" smtClean="0"/>
              <a:t> </a:t>
            </a:r>
            <a:r>
              <a:rPr lang="fr-FR" sz="1200" b="1" dirty="0" smtClean="0"/>
              <a:t>Figure A1 </a:t>
            </a:r>
            <a:r>
              <a:rPr lang="en-US" sz="1200" b="1" dirty="0" smtClean="0"/>
              <a:t>: </a:t>
            </a:r>
            <a:r>
              <a:rPr lang="en-US" sz="1200" b="1" dirty="0"/>
              <a:t>Influence of Triton X-100 concentration</a:t>
            </a:r>
            <a:r>
              <a:rPr lang="en-US" sz="1200" dirty="0"/>
              <a:t>: 3:1, 3:2, 6:1 and 6:2 (detergent/protein </a:t>
            </a:r>
            <a:r>
              <a:rPr lang="en-US" sz="1200" dirty="0" err="1"/>
              <a:t>ratio:final</a:t>
            </a:r>
            <a:r>
              <a:rPr lang="en-US" sz="1200" dirty="0"/>
              <a:t> detergent concentration) on </a:t>
            </a:r>
            <a:r>
              <a:rPr lang="en-US" sz="1200" b="1" dirty="0"/>
              <a:t>(A)</a:t>
            </a:r>
            <a:r>
              <a:rPr lang="en-US" sz="1200" dirty="0"/>
              <a:t> sterol enrichment and </a:t>
            </a:r>
            <a:r>
              <a:rPr lang="en-US" sz="1200" b="1" dirty="0"/>
              <a:t>(B)</a:t>
            </a:r>
            <a:r>
              <a:rPr lang="en-US" sz="1200" dirty="0"/>
              <a:t> quantitative and qualitative composition of LCB from 100 µg protein equivalents. Abbreviations used: t18:1(8Z): 4-hydroxysphing-8(Z)-</a:t>
            </a:r>
            <a:r>
              <a:rPr lang="en-US" sz="1200" dirty="0" err="1"/>
              <a:t>enine</a:t>
            </a:r>
            <a:r>
              <a:rPr lang="en-US" sz="1200" dirty="0"/>
              <a:t>, t18:1(8E): 4-hydroxysphing-8(E)-</a:t>
            </a:r>
            <a:r>
              <a:rPr lang="en-US" sz="1200" dirty="0" err="1"/>
              <a:t>enine</a:t>
            </a:r>
            <a:r>
              <a:rPr lang="en-US" sz="1200" dirty="0"/>
              <a:t>, t18:0: 4-hydroxysphinganine (</a:t>
            </a:r>
            <a:r>
              <a:rPr lang="en-US" sz="1200" dirty="0" err="1"/>
              <a:t>phytosphingosine</a:t>
            </a:r>
            <a:r>
              <a:rPr lang="en-US" sz="1200" dirty="0"/>
              <a:t>), d18:1(8Z): sphing-8(Z)-</a:t>
            </a:r>
            <a:r>
              <a:rPr lang="en-US" sz="1200" dirty="0" err="1"/>
              <a:t>enine</a:t>
            </a:r>
            <a:r>
              <a:rPr lang="en-US" sz="1200" dirty="0"/>
              <a:t>, d18:1(8E): sphing-8(E)-</a:t>
            </a:r>
            <a:r>
              <a:rPr lang="en-US" sz="1200" dirty="0" err="1"/>
              <a:t>enine</a:t>
            </a:r>
            <a:r>
              <a:rPr lang="en-US" sz="1200" dirty="0"/>
              <a:t>, d18:0: </a:t>
            </a:r>
            <a:r>
              <a:rPr lang="en-US" sz="1200" dirty="0" err="1"/>
              <a:t>sphinganine</a:t>
            </a:r>
            <a:r>
              <a:rPr lang="en-US" sz="1200" dirty="0"/>
              <a:t> (</a:t>
            </a:r>
            <a:r>
              <a:rPr lang="en-US" sz="1200" dirty="0" err="1"/>
              <a:t>dihydrosphingosine</a:t>
            </a:r>
            <a:r>
              <a:rPr lang="en-US" sz="1200" dirty="0"/>
              <a:t>), d18:2(4E,8E,Z): sphinga-4(E),8(E,Z)-</a:t>
            </a:r>
            <a:r>
              <a:rPr lang="en-US" sz="1200" dirty="0" err="1"/>
              <a:t>dienine</a:t>
            </a:r>
            <a:r>
              <a:rPr lang="en-US" sz="1200" dirty="0"/>
              <a:t>, d18:1(4E): 4-hydroxysphinganine. Results relative to sterol enrichment are expressed as the means ± SE (vertical bars) of at least three independent preparations.</a:t>
            </a:r>
            <a:endParaRPr lang="fr-FR" sz="1200" dirty="0"/>
          </a:p>
          <a:p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1259394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1</Words>
  <Application>Microsoft Office PowerPoint</Application>
  <PresentationFormat>Affichage à l'écra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ier</dc:creator>
  <cp:lastModifiedBy>Guillier</cp:lastModifiedBy>
  <cp:revision>2</cp:revision>
  <dcterms:created xsi:type="dcterms:W3CDTF">2014-05-26T11:37:22Z</dcterms:created>
  <dcterms:modified xsi:type="dcterms:W3CDTF">2014-05-26T12:15:36Z</dcterms:modified>
</cp:coreProperties>
</file>